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C56D0-4139-4AFB-B37A-A128B12D4F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A5692-3C06-4523-82A3-0FC3DB7540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FCAC6-BAB7-4D1F-B3D7-FF4A273E40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CA0C0-2091-4B64-8863-C993CC8B06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A6AF2-299B-4366-ABF8-ABF601275D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1DF8A-5AFF-4B7F-9C2B-1ACF6AF5D1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EAD34-2D67-4257-BD1B-37A0950155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759ED-E275-4A34-9422-E5C334EB60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BC7B3-055F-4BFB-B214-BB990AEE3D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1FCF3-6BB9-4126-8240-80F875D9D6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750D9B-7136-4B41-ABEB-AEFB6C0B5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8474E-8E2F-4391-951E-B65C5C0831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59D6E4-7A82-47BF-83E5-A332C334FF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3520" y="5028840"/>
            <a:ext cx="82296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3: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aplan-Meir plots show (a) male subjects were at higher risk of developing arsenic-induced skin lesion than the female subjects (p=4.5 E-35, log rank test; shown on left side) exposed to arsenic through drinking water; and (b) subjects with higher age (&gt;median 38 years) were also at higher risk for development of skin lesion (p=3.8 E-40; shown on right side) than those who were younger. X-axis represents time to event (months of follow-up after enrollment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457200" y="1415880"/>
            <a:ext cx="4038480" cy="3232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" descr=""/>
          <p:cNvPicPr/>
          <p:nvPr/>
        </p:nvPicPr>
        <p:blipFill>
          <a:blip r:embed="rId2"/>
          <a:stretch/>
        </p:blipFill>
        <p:spPr>
          <a:xfrm>
            <a:off x="4648320" y="1447920"/>
            <a:ext cx="4038480" cy="323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4:28Z</dcterms:modified>
  <cp:revision>34</cp:revision>
  <dc:subject/>
  <dc:title>Slide 1</dc:title>
</cp:coreProperties>
</file>